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608395-2093-45E2-8340-04D2C40FF5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D06013-9CD1-4574-A44A-688A6D51EA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EC652-CF24-4940-B0B7-B31079D69D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FB886-2D93-4AC9-BD6C-A6A3B03073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5D95F-F1FE-4D6A-B946-2127E5CB7C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585D7-132B-4463-B56F-78264D4327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E8BD6-9CA4-458D-A45D-D3D3744E2C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F0548-9B9C-4C1D-A981-441A1CC379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1C00B-FE66-4271-B8D0-0E85F9A008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64D7C-0B34-4745-A055-FAB312A33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0DD4F-F9AF-4490-9B1D-B81A3C669A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E0301-FD10-4F65-90E1-BCE6BEBB0A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B23AB6-B670-4BC7-8CE3-3A1A73BDA7B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2120" y="1371600"/>
          <a:ext cx="5587920" cy="2305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1371600"/>
                    <a:ext cx="5587920" cy="230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85800" y="6324480"/>
            <a:ext cx="5562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S1. Antitumor activity of SGN-35 in combination with vinorelbine in a  subcutaneous of L540cy HL tumors in SCID Mic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CID mice were implanted with L540cy HL cells in the right flank.  Groups of mice (9-10/group) were either untreated or received SGN-35 (1mg/kg, q4dx3, ip) and/or Gemcitabine (4mg/kg, q5dx3, ip) when tumor sized averaged approximately 100 m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1328760" y="1125360"/>
          <a:ext cx="4203720" cy="2167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28760" y="1125360"/>
                    <a:ext cx="4203720" cy="2167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1479600" y="3790800"/>
          <a:ext cx="4541760" cy="21686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479600" y="3790800"/>
                    <a:ext cx="4541760" cy="2168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" name=""/>
          <p:cNvSpPr/>
          <p:nvPr/>
        </p:nvSpPr>
        <p:spPr>
          <a:xfrm>
            <a:off x="685800" y="6324480"/>
            <a:ext cx="55627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S2. Mean percent body weight change of  L540cy H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umor bearing animals. (A). ABVD study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roups of mice (9-10/group) were either untreated or received SGN-35 (1mg/kg, q4dx3, ip) and/or ABVD:  (Adriamycin (0.75 mg/kg, q4dx3, i.v.), Bleomycin (6u/kg, q4dx3, i.p.), Vinblastine (0.01 mg/kg, q4dx3, i.p.), and Dacarbazine (15 mg/kg, q3dx4, i.p.))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.Gemcitabine stud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Groups of mice (5-10/group) were untreated or received SGN-35 (1mg/kg, q4dx3, ip) and/or Gemcitabine (120 mg/kg, q4dx3, ip). Onset of the treatments is labeled as day 0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976320" y="72216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068120" y="342900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1T22:12:23Z</dcterms:created>
  <dc:creator>Ezogelin Oflazoglu</dc:creator>
  <dc:description/>
  <dc:language>en-US</dc:language>
  <cp:lastModifiedBy>hgerber</cp:lastModifiedBy>
  <dcterms:modified xsi:type="dcterms:W3CDTF">2008-01-22T01:17:52Z</dcterms:modified>
  <cp:revision>8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884251084</vt:r8>
  </property>
  <property fmtid="{D5CDD505-2E9C-101B-9397-08002B2CF9AE}" pid="3" name="_AuthorEmail">
    <vt:lpwstr>hgerber@seagen.com</vt:lpwstr>
  </property>
  <property fmtid="{D5CDD505-2E9C-101B-9397-08002B2CF9AE}" pid="4" name="_AuthorEmailDisplayName">
    <vt:lpwstr>Hanspeter Gerber</vt:lpwstr>
  </property>
  <property fmtid="{D5CDD505-2E9C-101B-9397-08002B2CF9AE}" pid="5" name="_EmailSubject">
    <vt:lpwstr>BJH ms files</vt:lpwstr>
  </property>
</Properties>
</file>